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407" r:id="rId2"/>
  </p:sldIdLst>
  <p:sldSz cx="6858000" cy="9906000" type="A4"/>
  <p:notesSz cx="6735763" cy="9866313"/>
  <p:defaultTextStyle>
    <a:defPPr>
      <a:defRPr lang="ja-JP"/>
    </a:defPPr>
    <a:lvl1pPr marL="0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1pPr>
    <a:lvl2pPr marL="698464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2pPr>
    <a:lvl3pPr marL="1396929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3pPr>
    <a:lvl4pPr marL="2095393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4pPr>
    <a:lvl5pPr marL="2793858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5pPr>
    <a:lvl6pPr marL="3492322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6pPr>
    <a:lvl7pPr marL="4190787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7pPr>
    <a:lvl8pPr marL="4889251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8pPr>
    <a:lvl9pPr marL="5587716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高橋秀和" initials="高橋秀和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93" autoAdjust="0"/>
    <p:restoredTop sz="96429" autoAdjust="0"/>
  </p:normalViewPr>
  <p:slideViewPr>
    <p:cSldViewPr snapToGrid="0">
      <p:cViewPr varScale="1">
        <p:scale>
          <a:sx n="88" d="100"/>
          <a:sy n="88" d="100"/>
        </p:scale>
        <p:origin x="3180" y="1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0e63f4543d3ba298/&#35542;&#25991;figure&#29992;-&#35299;&#26512;&#12487;&#12540;&#12479;-0830-1000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0e63f4543d3ba298/&#35542;&#25991;figure&#29992;-&#35299;&#26512;&#12487;&#12540;&#12479;-0830-100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相関図miR-16'!$B$3:$B$32</c:f>
              <c:numCache>
                <c:formatCode>General</c:formatCode>
                <c:ptCount val="30"/>
                <c:pt idx="0">
                  <c:v>0.38706684000000002</c:v>
                </c:pt>
                <c:pt idx="1">
                  <c:v>1.7989177999999999</c:v>
                </c:pt>
                <c:pt idx="2">
                  <c:v>2.0274858</c:v>
                </c:pt>
                <c:pt idx="3">
                  <c:v>0.82632256000000004</c:v>
                </c:pt>
                <c:pt idx="4">
                  <c:v>0.23774433</c:v>
                </c:pt>
                <c:pt idx="5">
                  <c:v>1.449678</c:v>
                </c:pt>
                <c:pt idx="6">
                  <c:v>1.4773559999999999</c:v>
                </c:pt>
                <c:pt idx="7">
                  <c:v>0.85531663999999996</c:v>
                </c:pt>
                <c:pt idx="8">
                  <c:v>2.0571852000000002</c:v>
                </c:pt>
                <c:pt idx="9">
                  <c:v>1.2051023999999999</c:v>
                </c:pt>
                <c:pt idx="10">
                  <c:v>1.9906372999999999</c:v>
                </c:pt>
                <c:pt idx="11">
                  <c:v>2.0314040000000002</c:v>
                </c:pt>
                <c:pt idx="12">
                  <c:v>1.4687428</c:v>
                </c:pt>
                <c:pt idx="13">
                  <c:v>2.2819957999999998</c:v>
                </c:pt>
                <c:pt idx="14">
                  <c:v>1.6559405</c:v>
                </c:pt>
                <c:pt idx="15">
                  <c:v>1.4121060000000001</c:v>
                </c:pt>
                <c:pt idx="16">
                  <c:v>1.8129044000000001</c:v>
                </c:pt>
                <c:pt idx="17">
                  <c:v>2.9245376999999999E-2</c:v>
                </c:pt>
                <c:pt idx="18">
                  <c:v>0.7327051</c:v>
                </c:pt>
                <c:pt idx="19">
                  <c:v>0.98271704000000004</c:v>
                </c:pt>
                <c:pt idx="20">
                  <c:v>0.94176099999999996</c:v>
                </c:pt>
                <c:pt idx="21">
                  <c:v>0.77279949999999997</c:v>
                </c:pt>
                <c:pt idx="22">
                  <c:v>2.029811</c:v>
                </c:pt>
                <c:pt idx="23">
                  <c:v>1.7141719</c:v>
                </c:pt>
                <c:pt idx="24">
                  <c:v>-0.20313406000000001</c:v>
                </c:pt>
                <c:pt idx="25">
                  <c:v>2.3936848999999998</c:v>
                </c:pt>
                <c:pt idx="26">
                  <c:v>1.0409508000000001</c:v>
                </c:pt>
                <c:pt idx="27">
                  <c:v>2.6570778000000002</c:v>
                </c:pt>
                <c:pt idx="28">
                  <c:v>0.85707473999999995</c:v>
                </c:pt>
                <c:pt idx="29">
                  <c:v>1.2041615999999999</c:v>
                </c:pt>
              </c:numCache>
            </c:numRef>
          </c:xVal>
          <c:yVal>
            <c:numRef>
              <c:f>'相関図miR-16'!$C$3:$C$32</c:f>
              <c:numCache>
                <c:formatCode>General</c:formatCode>
                <c:ptCount val="30"/>
                <c:pt idx="0">
                  <c:v>24.375</c:v>
                </c:pt>
                <c:pt idx="1">
                  <c:v>23.225000000000001</c:v>
                </c:pt>
                <c:pt idx="2">
                  <c:v>23.19</c:v>
                </c:pt>
                <c:pt idx="3">
                  <c:v>23.785</c:v>
                </c:pt>
                <c:pt idx="4">
                  <c:v>22.66</c:v>
                </c:pt>
                <c:pt idx="5">
                  <c:v>23.145</c:v>
                </c:pt>
                <c:pt idx="6">
                  <c:v>23.055</c:v>
                </c:pt>
                <c:pt idx="7">
                  <c:v>24.01</c:v>
                </c:pt>
                <c:pt idx="8">
                  <c:v>23.795000000000002</c:v>
                </c:pt>
                <c:pt idx="9">
                  <c:v>23.405000000000001</c:v>
                </c:pt>
                <c:pt idx="10">
                  <c:v>22.63</c:v>
                </c:pt>
                <c:pt idx="11">
                  <c:v>22.14</c:v>
                </c:pt>
                <c:pt idx="12">
                  <c:v>23.490000000000002</c:v>
                </c:pt>
                <c:pt idx="13">
                  <c:v>21.450000000000003</c:v>
                </c:pt>
                <c:pt idx="14">
                  <c:v>22.630000000000003</c:v>
                </c:pt>
                <c:pt idx="15">
                  <c:v>23.645</c:v>
                </c:pt>
                <c:pt idx="16">
                  <c:v>22.67</c:v>
                </c:pt>
                <c:pt idx="17">
                  <c:v>25.795000000000002</c:v>
                </c:pt>
                <c:pt idx="18">
                  <c:v>23.95</c:v>
                </c:pt>
                <c:pt idx="19">
                  <c:v>24.03</c:v>
                </c:pt>
                <c:pt idx="20">
                  <c:v>22.81</c:v>
                </c:pt>
                <c:pt idx="21">
                  <c:v>24.335000000000001</c:v>
                </c:pt>
                <c:pt idx="22">
                  <c:v>23.35</c:v>
                </c:pt>
                <c:pt idx="23">
                  <c:v>24.285</c:v>
                </c:pt>
                <c:pt idx="24">
                  <c:v>26.155000000000001</c:v>
                </c:pt>
                <c:pt idx="25">
                  <c:v>22.075000000000003</c:v>
                </c:pt>
                <c:pt idx="26">
                  <c:v>26.335000000000001</c:v>
                </c:pt>
                <c:pt idx="27">
                  <c:v>23</c:v>
                </c:pt>
                <c:pt idx="28">
                  <c:v>25.12</c:v>
                </c:pt>
                <c:pt idx="29">
                  <c:v>23.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A5D-4E8A-B718-2A2C2C4B27B5}"/>
            </c:ext>
          </c:extLst>
        </c:ser>
        <c:ser>
          <c:idx val="0"/>
          <c:order val="1"/>
          <c:spPr>
            <a:ln w="19050" cap="rnd">
              <a:solidFill>
                <a:schemeClr val="bg1"/>
              </a:solidFill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bg1"/>
                </a:solidFill>
              </a:ln>
              <a:effectLst/>
            </c:spPr>
          </c:marker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01-FA5D-4E8A-B718-2A2C2C4B27B5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図miR-16'!$B$3:$B$32</c:f>
              <c:numCache>
                <c:formatCode>General</c:formatCode>
                <c:ptCount val="30"/>
                <c:pt idx="0">
                  <c:v>0.38706684000000002</c:v>
                </c:pt>
                <c:pt idx="1">
                  <c:v>1.7989177999999999</c:v>
                </c:pt>
                <c:pt idx="2">
                  <c:v>2.0274858</c:v>
                </c:pt>
                <c:pt idx="3">
                  <c:v>0.82632256000000004</c:v>
                </c:pt>
                <c:pt idx="4">
                  <c:v>0.23774433</c:v>
                </c:pt>
                <c:pt idx="5">
                  <c:v>1.449678</c:v>
                </c:pt>
                <c:pt idx="6">
                  <c:v>1.4773559999999999</c:v>
                </c:pt>
                <c:pt idx="7">
                  <c:v>0.85531663999999996</c:v>
                </c:pt>
                <c:pt idx="8">
                  <c:v>2.0571852000000002</c:v>
                </c:pt>
                <c:pt idx="9">
                  <c:v>1.2051023999999999</c:v>
                </c:pt>
                <c:pt idx="10">
                  <c:v>1.9906372999999999</c:v>
                </c:pt>
                <c:pt idx="11">
                  <c:v>2.0314040000000002</c:v>
                </c:pt>
                <c:pt idx="12">
                  <c:v>1.4687428</c:v>
                </c:pt>
                <c:pt idx="13">
                  <c:v>2.2819957999999998</c:v>
                </c:pt>
                <c:pt idx="14">
                  <c:v>1.6559405</c:v>
                </c:pt>
                <c:pt idx="15">
                  <c:v>1.4121060000000001</c:v>
                </c:pt>
                <c:pt idx="16">
                  <c:v>1.8129044000000001</c:v>
                </c:pt>
                <c:pt idx="17">
                  <c:v>2.9245376999999999E-2</c:v>
                </c:pt>
                <c:pt idx="18">
                  <c:v>0.7327051</c:v>
                </c:pt>
                <c:pt idx="19">
                  <c:v>0.98271704000000004</c:v>
                </c:pt>
                <c:pt idx="20">
                  <c:v>0.94176099999999996</c:v>
                </c:pt>
                <c:pt idx="21">
                  <c:v>0.77279949999999997</c:v>
                </c:pt>
                <c:pt idx="22">
                  <c:v>2.029811</c:v>
                </c:pt>
                <c:pt idx="23">
                  <c:v>1.7141719</c:v>
                </c:pt>
                <c:pt idx="24">
                  <c:v>-0.20313406000000001</c:v>
                </c:pt>
                <c:pt idx="25">
                  <c:v>2.3936848999999998</c:v>
                </c:pt>
                <c:pt idx="26">
                  <c:v>1.0409508000000001</c:v>
                </c:pt>
                <c:pt idx="27">
                  <c:v>2.6570778000000002</c:v>
                </c:pt>
                <c:pt idx="28">
                  <c:v>0.85707473999999995</c:v>
                </c:pt>
                <c:pt idx="29">
                  <c:v>1.2041615999999999</c:v>
                </c:pt>
              </c:numCache>
            </c:numRef>
          </c:xVal>
          <c:yVal>
            <c:numRef>
              <c:f>'相関図miR-16'!$C$3:$C$32</c:f>
              <c:numCache>
                <c:formatCode>General</c:formatCode>
                <c:ptCount val="30"/>
                <c:pt idx="0">
                  <c:v>24.375</c:v>
                </c:pt>
                <c:pt idx="1">
                  <c:v>23.225000000000001</c:v>
                </c:pt>
                <c:pt idx="2">
                  <c:v>23.19</c:v>
                </c:pt>
                <c:pt idx="3">
                  <c:v>23.785</c:v>
                </c:pt>
                <c:pt idx="4">
                  <c:v>22.66</c:v>
                </c:pt>
                <c:pt idx="5">
                  <c:v>23.145</c:v>
                </c:pt>
                <c:pt idx="6">
                  <c:v>23.055</c:v>
                </c:pt>
                <c:pt idx="7">
                  <c:v>24.01</c:v>
                </c:pt>
                <c:pt idx="8">
                  <c:v>23.795000000000002</c:v>
                </c:pt>
                <c:pt idx="9">
                  <c:v>23.405000000000001</c:v>
                </c:pt>
                <c:pt idx="10">
                  <c:v>22.63</c:v>
                </c:pt>
                <c:pt idx="11">
                  <c:v>22.14</c:v>
                </c:pt>
                <c:pt idx="12">
                  <c:v>23.490000000000002</c:v>
                </c:pt>
                <c:pt idx="13">
                  <c:v>21.450000000000003</c:v>
                </c:pt>
                <c:pt idx="14">
                  <c:v>22.630000000000003</c:v>
                </c:pt>
                <c:pt idx="15">
                  <c:v>23.645</c:v>
                </c:pt>
                <c:pt idx="16">
                  <c:v>22.67</c:v>
                </c:pt>
                <c:pt idx="17">
                  <c:v>25.795000000000002</c:v>
                </c:pt>
                <c:pt idx="18">
                  <c:v>23.95</c:v>
                </c:pt>
                <c:pt idx="19">
                  <c:v>24.03</c:v>
                </c:pt>
                <c:pt idx="20">
                  <c:v>22.81</c:v>
                </c:pt>
                <c:pt idx="21">
                  <c:v>24.335000000000001</c:v>
                </c:pt>
                <c:pt idx="22">
                  <c:v>23.35</c:v>
                </c:pt>
                <c:pt idx="23">
                  <c:v>24.285</c:v>
                </c:pt>
                <c:pt idx="24">
                  <c:v>26.155000000000001</c:v>
                </c:pt>
                <c:pt idx="25">
                  <c:v>22.075000000000003</c:v>
                </c:pt>
                <c:pt idx="26">
                  <c:v>26.335000000000001</c:v>
                </c:pt>
                <c:pt idx="27">
                  <c:v>23</c:v>
                </c:pt>
                <c:pt idx="28">
                  <c:v>25.12</c:v>
                </c:pt>
                <c:pt idx="29">
                  <c:v>23.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A5D-4E8A-B718-2A2C2C4B27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44224"/>
        <c:axId val="203561456"/>
      </c:scatterChart>
      <c:valAx>
        <c:axId val="6444224"/>
        <c:scaling>
          <c:orientation val="minMax"/>
          <c:max val="3"/>
          <c:min val="-0.5"/>
        </c:scaling>
        <c:delete val="0"/>
        <c:axPos val="t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3561456"/>
        <c:crossesAt val="27"/>
        <c:crossBetween val="midCat"/>
        <c:majorUnit val="1"/>
      </c:valAx>
      <c:valAx>
        <c:axId val="203561456"/>
        <c:scaling>
          <c:orientation val="maxMin"/>
          <c:max val="27"/>
          <c:min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44224"/>
        <c:crossesAt val="-0.5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'相関図miR-193'!$B$66:$B$95</c:f>
              <c:numCache>
                <c:formatCode>General</c:formatCode>
                <c:ptCount val="30"/>
                <c:pt idx="0">
                  <c:v>-10.427204</c:v>
                </c:pt>
                <c:pt idx="1">
                  <c:v>-2.0302142999999999</c:v>
                </c:pt>
                <c:pt idx="2">
                  <c:v>-3.8357991999999999</c:v>
                </c:pt>
                <c:pt idx="3">
                  <c:v>-3.9951732</c:v>
                </c:pt>
                <c:pt idx="4">
                  <c:v>-3.2255492000000001</c:v>
                </c:pt>
                <c:pt idx="5">
                  <c:v>-9.5374490000000005</c:v>
                </c:pt>
                <c:pt idx="6">
                  <c:v>-4.2308154</c:v>
                </c:pt>
                <c:pt idx="7">
                  <c:v>-10.433748</c:v>
                </c:pt>
                <c:pt idx="8">
                  <c:v>-9.3227700000000002</c:v>
                </c:pt>
                <c:pt idx="9">
                  <c:v>-8.3366209999999992</c:v>
                </c:pt>
                <c:pt idx="10">
                  <c:v>-2.0568233</c:v>
                </c:pt>
                <c:pt idx="11">
                  <c:v>-3.9338082999999999</c:v>
                </c:pt>
                <c:pt idx="12">
                  <c:v>-9.5908420000000003</c:v>
                </c:pt>
                <c:pt idx="13">
                  <c:v>-9.6764119999999991</c:v>
                </c:pt>
                <c:pt idx="14">
                  <c:v>-10.207228000000001</c:v>
                </c:pt>
                <c:pt idx="15">
                  <c:v>-3.5229857</c:v>
                </c:pt>
                <c:pt idx="16">
                  <c:v>-1.4901652000000001</c:v>
                </c:pt>
                <c:pt idx="17">
                  <c:v>-9.0966889999999996</c:v>
                </c:pt>
                <c:pt idx="18">
                  <c:v>-1.9732828</c:v>
                </c:pt>
                <c:pt idx="19">
                  <c:v>-2.3626985999999999</c:v>
                </c:pt>
                <c:pt idx="20">
                  <c:v>-3.9842936999999998</c:v>
                </c:pt>
                <c:pt idx="21">
                  <c:v>-1.860004</c:v>
                </c:pt>
                <c:pt idx="22">
                  <c:v>-10.026176</c:v>
                </c:pt>
                <c:pt idx="23">
                  <c:v>-8.9898969999999991</c:v>
                </c:pt>
                <c:pt idx="24">
                  <c:v>-2.6302957999999999</c:v>
                </c:pt>
                <c:pt idx="25">
                  <c:v>-2.5930886000000002</c:v>
                </c:pt>
                <c:pt idx="26">
                  <c:v>-7.5783668000000004</c:v>
                </c:pt>
                <c:pt idx="27">
                  <c:v>-2.0939511999999998</c:v>
                </c:pt>
                <c:pt idx="28">
                  <c:v>-7.3927449999999997</c:v>
                </c:pt>
                <c:pt idx="29">
                  <c:v>-3.4732310000000002</c:v>
                </c:pt>
              </c:numCache>
            </c:numRef>
          </c:xVal>
          <c:yVal>
            <c:numRef>
              <c:f>'相関図miR-193'!$C$66:$C$95</c:f>
              <c:numCache>
                <c:formatCode>General</c:formatCode>
                <c:ptCount val="30"/>
                <c:pt idx="0">
                  <c:v>33.03</c:v>
                </c:pt>
                <c:pt idx="1">
                  <c:v>30.47</c:v>
                </c:pt>
                <c:pt idx="2">
                  <c:v>31.35</c:v>
                </c:pt>
                <c:pt idx="3">
                  <c:v>31.204999999999998</c:v>
                </c:pt>
                <c:pt idx="4">
                  <c:v>29.795000000000002</c:v>
                </c:pt>
                <c:pt idx="5">
                  <c:v>31.574999999999999</c:v>
                </c:pt>
                <c:pt idx="6">
                  <c:v>31.89</c:v>
                </c:pt>
                <c:pt idx="7">
                  <c:v>32.284999999999997</c:v>
                </c:pt>
                <c:pt idx="8">
                  <c:v>32.254999999999995</c:v>
                </c:pt>
                <c:pt idx="9">
                  <c:v>32.634999999999998</c:v>
                </c:pt>
                <c:pt idx="10">
                  <c:v>29.89</c:v>
                </c:pt>
                <c:pt idx="11">
                  <c:v>30.619999999999997</c:v>
                </c:pt>
                <c:pt idx="12">
                  <c:v>31.745000000000001</c:v>
                </c:pt>
                <c:pt idx="13">
                  <c:v>31.31</c:v>
                </c:pt>
                <c:pt idx="14">
                  <c:v>31.204999999999998</c:v>
                </c:pt>
                <c:pt idx="15">
                  <c:v>31.024999999999999</c:v>
                </c:pt>
                <c:pt idx="16">
                  <c:v>29.545000000000002</c:v>
                </c:pt>
                <c:pt idx="17">
                  <c:v>33.174999999999997</c:v>
                </c:pt>
                <c:pt idx="18">
                  <c:v>29.605</c:v>
                </c:pt>
                <c:pt idx="19">
                  <c:v>30.195</c:v>
                </c:pt>
                <c:pt idx="20">
                  <c:v>30.59</c:v>
                </c:pt>
                <c:pt idx="21">
                  <c:v>29.924999999999997</c:v>
                </c:pt>
                <c:pt idx="22">
                  <c:v>32.305</c:v>
                </c:pt>
                <c:pt idx="23">
                  <c:v>31.854999999999997</c:v>
                </c:pt>
                <c:pt idx="24">
                  <c:v>30.64</c:v>
                </c:pt>
                <c:pt idx="25">
                  <c:v>29.77</c:v>
                </c:pt>
                <c:pt idx="26">
                  <c:v>33.394999999999996</c:v>
                </c:pt>
                <c:pt idx="27">
                  <c:v>29.625</c:v>
                </c:pt>
                <c:pt idx="28">
                  <c:v>31.99</c:v>
                </c:pt>
                <c:pt idx="29">
                  <c:v>30.094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CAE-4A27-B0E6-4F3CC289FE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1965624"/>
        <c:axId val="203158280"/>
      </c:scatterChart>
      <c:valAx>
        <c:axId val="141965624"/>
        <c:scaling>
          <c:orientation val="minMax"/>
        </c:scaling>
        <c:delete val="0"/>
        <c:axPos val="t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3158280"/>
        <c:crossesAt val="34"/>
        <c:crossBetween val="midCat"/>
        <c:majorUnit val="4"/>
      </c:valAx>
      <c:valAx>
        <c:axId val="203158280"/>
        <c:scaling>
          <c:orientation val="maxMin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41965624"/>
        <c:crossesAt val="-12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104E8E-E397-426E-B79F-EFA96C158524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3A159B-C8C1-41ED-8E71-A1A47EFD4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42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1pPr>
    <a:lvl2pPr marL="698464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2pPr>
    <a:lvl3pPr marL="1396929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3pPr>
    <a:lvl4pPr marL="2095393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4pPr>
    <a:lvl5pPr marL="2793858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5pPr>
    <a:lvl6pPr marL="3492322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6pPr>
    <a:lvl7pPr marL="4190787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7pPr>
    <a:lvl8pPr marL="4889251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8pPr>
    <a:lvl9pPr marL="5587716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16150" y="1233488"/>
            <a:ext cx="2303463" cy="33289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baseline="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3A159B-C8C1-41ED-8E71-A1A47EFD4D0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55280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400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458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246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170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66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612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732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281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788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943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043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6311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/>
          <p:cNvSpPr txBox="1"/>
          <p:nvPr/>
        </p:nvSpPr>
        <p:spPr>
          <a:xfrm>
            <a:off x="1830071" y="708261"/>
            <a:ext cx="290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1214799"/>
              </p:ext>
            </p:extLst>
          </p:nvPr>
        </p:nvGraphicFramePr>
        <p:xfrm>
          <a:off x="2250510" y="3491786"/>
          <a:ext cx="3091043" cy="2406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3251580" y="5802659"/>
            <a:ext cx="12733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R-16 Sign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miRNA microarray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1552986" y="4353311"/>
            <a:ext cx="1213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t: miR-16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PCR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8880179"/>
              </p:ext>
            </p:extLst>
          </p:nvPr>
        </p:nvGraphicFramePr>
        <p:xfrm>
          <a:off x="2250510" y="790574"/>
          <a:ext cx="3091043" cy="2406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" name="テキスト ボックス 17"/>
          <p:cNvSpPr txBox="1"/>
          <p:nvPr/>
        </p:nvSpPr>
        <p:spPr>
          <a:xfrm rot="16200000">
            <a:off x="1642339" y="1785092"/>
            <a:ext cx="1034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t: miR-193a-3p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PCR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057270" y="3097731"/>
            <a:ext cx="16619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R-193a-3p Sign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miRNA microarray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830071" y="3382307"/>
            <a:ext cx="290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270741" y="2409498"/>
            <a:ext cx="7346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0.8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351916" y="5129376"/>
            <a:ext cx="7346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0.67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6063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38</TotalTime>
  <Words>37</Words>
  <Application>Microsoft Office PowerPoint</Application>
  <PresentationFormat>A4 210 x 297 mm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橋秀和</dc:creator>
  <cp:lastModifiedBy>Masa-XPS</cp:lastModifiedBy>
  <cp:revision>1162</cp:revision>
  <cp:lastPrinted>2014-09-14T11:23:03Z</cp:lastPrinted>
  <dcterms:created xsi:type="dcterms:W3CDTF">2013-10-03T08:05:32Z</dcterms:created>
  <dcterms:modified xsi:type="dcterms:W3CDTF">2017-08-26T06:31:11Z</dcterms:modified>
</cp:coreProperties>
</file>